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592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768" userDrawn="1">
          <p15:clr>
            <a:srgbClr val="A4A3A4"/>
          </p15:clr>
        </p15:guide>
        <p15:guide id="2" pos="32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149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264" y="114"/>
      </p:cViewPr>
      <p:guideLst>
        <p:guide orient="horz" pos="768"/>
        <p:guide pos="3264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338" y="0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FD06668-9299-4126-A0BE-E9B1D145BB51}" type="datetimeFigureOut">
              <a:rPr lang="en-US" smtClean="0"/>
              <a:t>1/13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14463" y="1162050"/>
            <a:ext cx="4181475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675" y="4473575"/>
            <a:ext cx="5607050" cy="36607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338" y="8829675"/>
            <a:ext cx="3038475" cy="46672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EF505E7-631E-4AEE-8130-EDFBAFC5DC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4246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0BA2E4-B80E-48A2-BAD5-8F36957696A4}" type="datetime1">
              <a:rPr lang="en-US" smtClean="0"/>
              <a:t>1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8D30-E7B8-4A9E-BAD0-68F332A4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0130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18C67B-227D-40D0-81A8-25CD88102DD9}" type="datetime1">
              <a:rPr lang="en-US" smtClean="0"/>
              <a:t>1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8D30-E7B8-4A9E-BAD0-68F332A4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6186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C6FBC35-1BDB-4444-A540-EE59827C47ED}" type="datetime1">
              <a:rPr lang="en-US" smtClean="0"/>
              <a:t>1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8D30-E7B8-4A9E-BAD0-68F332A4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62557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77F6A7-8D3F-4BA4-B05E-EAAF7885E1AE}" type="datetime1">
              <a:rPr lang="en-US" smtClean="0"/>
              <a:t>1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8D30-E7B8-4A9E-BAD0-68F332A4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379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4BE11C-C8EC-43E7-AAFB-B98D7F605EE3}" type="datetime1">
              <a:rPr lang="en-US" smtClean="0"/>
              <a:t>1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8D30-E7B8-4A9E-BAD0-68F332A4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710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EC6BF2-EA90-4181-9135-7DF15803510D}" type="datetime1">
              <a:rPr lang="en-US" smtClean="0"/>
              <a:t>1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8D30-E7B8-4A9E-BAD0-68F332A4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501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F38BA7-78CD-4C1C-98FB-37644707C0D8}" type="datetime1">
              <a:rPr lang="en-US" smtClean="0"/>
              <a:t>1/1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8D30-E7B8-4A9E-BAD0-68F332A4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83295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12CDFF-001A-4F10-ACF3-36E8CB39BFF1}" type="datetime1">
              <a:rPr lang="en-US" smtClean="0"/>
              <a:t>1/1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8D30-E7B8-4A9E-BAD0-68F332A4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7155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B0B62E-7AE5-4490-80F7-F0E44D38BD8E}" type="datetime1">
              <a:rPr lang="en-US" smtClean="0"/>
              <a:t>1/1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8D30-E7B8-4A9E-BAD0-68F332A4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73734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75A342-05DE-4A06-841C-9BCDE46DCF6A}" type="datetime1">
              <a:rPr lang="en-US" smtClean="0"/>
              <a:t>1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8D30-E7B8-4A9E-BAD0-68F332A4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9710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82C5C5-49C3-4B55-AB85-A4E4DED9AC41}" type="datetime1">
              <a:rPr lang="en-US" smtClean="0"/>
              <a:t>1/1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C58D30-E7B8-4A9E-BAD0-68F332A4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138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88E46C-40B9-44E3-BC4F-F8ABF05A16E3}" type="datetime1">
              <a:rPr lang="en-US" smtClean="0"/>
              <a:t>1/1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C58D30-E7B8-4A9E-BAD0-68F332A40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066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21013" y="128702"/>
            <a:ext cx="7873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692237" y="5676541"/>
            <a:ext cx="9348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ample port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" name="Straight Arrow Connector 7"/>
          <p:cNvCxnSpPr/>
          <p:nvPr/>
        </p:nvCxnSpPr>
        <p:spPr>
          <a:xfrm flipV="1">
            <a:off x="3198145" y="5325797"/>
            <a:ext cx="0" cy="318977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74435" y="3795201"/>
            <a:ext cx="9000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uffer port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Straight Arrow Connector 9"/>
          <p:cNvCxnSpPr/>
          <p:nvPr/>
        </p:nvCxnSpPr>
        <p:spPr>
          <a:xfrm flipV="1">
            <a:off x="1395664" y="3933701"/>
            <a:ext cx="172429" cy="3028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6370452" y="5931998"/>
            <a:ext cx="15942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rtical strip (S1 strip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506907" y="3222631"/>
            <a:ext cx="15776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teral strip (S2 Strip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630779" y="2945632"/>
            <a:ext cx="194226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loidal gold protein A pad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Rectangle 21"/>
          <p:cNvSpPr/>
          <p:nvPr/>
        </p:nvSpPr>
        <p:spPr>
          <a:xfrm rot="16200000">
            <a:off x="605494" y="1692768"/>
            <a:ext cx="52578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3"/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13 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1 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/shorebird/DE/68/2004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3"/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/B+B/W HA1 (B/Brisbane/60/2008 and B/Wisconsin/1/2010)</a:t>
            </a:r>
          </a:p>
          <a:p>
            <a:pPr lvl="3"/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1/ 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3 HA1 (A/CA/07/2009+A/Per/16/2009)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3"/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2 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1 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/Japan/305/57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3"/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5 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1 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/Indonesia/05/2005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3"/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7-N 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1 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/Shanghai/2/2013</a:t>
            </a:r>
            <a:endParaRPr 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3"/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9 </a:t>
            </a:r>
            <a:r>
              <a:rPr lang="en-US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A1 A/Hong </a:t>
            </a:r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ong/33982/2009</a:t>
            </a:r>
          </a:p>
          <a:p>
            <a:pPr lvl="3"/>
            <a:r>
              <a:rPr lang="en-US" sz="9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 control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35125" y="3589117"/>
            <a:ext cx="2889250" cy="1584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440094" y="3572212"/>
            <a:ext cx="2902002" cy="15719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8" name="Straight Connector 17"/>
          <p:cNvCxnSpPr/>
          <p:nvPr/>
        </p:nvCxnSpPr>
        <p:spPr>
          <a:xfrm>
            <a:off x="5248784" y="3565283"/>
            <a:ext cx="381370" cy="39954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/>
          <p:cNvCxnSpPr/>
          <p:nvPr/>
        </p:nvCxnSpPr>
        <p:spPr>
          <a:xfrm flipH="1">
            <a:off x="6247775" y="3267128"/>
            <a:ext cx="402402" cy="49792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Connector 27"/>
          <p:cNvCxnSpPr/>
          <p:nvPr/>
        </p:nvCxnSpPr>
        <p:spPr>
          <a:xfrm>
            <a:off x="6975570" y="4918682"/>
            <a:ext cx="0" cy="89635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214212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423</TotalTime>
  <Words>55</Words>
  <Application>Microsoft Office PowerPoint</Application>
  <PresentationFormat>On-screen Show (4:3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Centers for Disease Control and Prevention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Zhunan (CDC/OID/NCIRD)</dc:creator>
  <cp:lastModifiedBy>Li, Zhunan (CDC/OID/NCIRD)</cp:lastModifiedBy>
  <cp:revision>407</cp:revision>
  <cp:lastPrinted>2016-10-07T16:05:45Z</cp:lastPrinted>
  <dcterms:created xsi:type="dcterms:W3CDTF">2016-02-17T15:21:30Z</dcterms:created>
  <dcterms:modified xsi:type="dcterms:W3CDTF">2017-01-13T18:08:55Z</dcterms:modified>
</cp:coreProperties>
</file>